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4" autoAdjust="0"/>
    <p:restoredTop sz="94660"/>
  </p:normalViewPr>
  <p:slideViewPr>
    <p:cSldViewPr snapToGrid="0">
      <p:cViewPr varScale="1">
        <p:scale>
          <a:sx n="69" d="100"/>
          <a:sy n="69" d="100"/>
        </p:scale>
        <p:origin x="56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D867E-046E-44E4-99D4-23F228E76632}" type="datetimeFigureOut">
              <a:rPr lang="en-US" smtClean="0"/>
              <a:t>9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704B-E8A6-4BBA-87B8-246A026C1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027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D867E-046E-44E4-99D4-23F228E76632}" type="datetimeFigureOut">
              <a:rPr lang="en-US" smtClean="0"/>
              <a:t>9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704B-E8A6-4BBA-87B8-246A026C1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390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D867E-046E-44E4-99D4-23F228E76632}" type="datetimeFigureOut">
              <a:rPr lang="en-US" smtClean="0"/>
              <a:t>9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704B-E8A6-4BBA-87B8-246A026C1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552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D867E-046E-44E4-99D4-23F228E76632}" type="datetimeFigureOut">
              <a:rPr lang="en-US" smtClean="0"/>
              <a:t>9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704B-E8A6-4BBA-87B8-246A026C1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009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D867E-046E-44E4-99D4-23F228E76632}" type="datetimeFigureOut">
              <a:rPr lang="en-US" smtClean="0"/>
              <a:t>9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704B-E8A6-4BBA-87B8-246A026C1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037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D867E-046E-44E4-99D4-23F228E76632}" type="datetimeFigureOut">
              <a:rPr lang="en-US" smtClean="0"/>
              <a:t>9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704B-E8A6-4BBA-87B8-246A026C1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6137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D867E-046E-44E4-99D4-23F228E76632}" type="datetimeFigureOut">
              <a:rPr lang="en-US" smtClean="0"/>
              <a:t>9/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704B-E8A6-4BBA-87B8-246A026C1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586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D867E-046E-44E4-99D4-23F228E76632}" type="datetimeFigureOut">
              <a:rPr lang="en-US" smtClean="0"/>
              <a:t>9/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704B-E8A6-4BBA-87B8-246A026C1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2787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D867E-046E-44E4-99D4-23F228E76632}" type="datetimeFigureOut">
              <a:rPr lang="en-US" smtClean="0"/>
              <a:t>9/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704B-E8A6-4BBA-87B8-246A026C1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5085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D867E-046E-44E4-99D4-23F228E76632}" type="datetimeFigureOut">
              <a:rPr lang="en-US" smtClean="0"/>
              <a:t>9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704B-E8A6-4BBA-87B8-246A026C1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1137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CD867E-046E-44E4-99D4-23F228E76632}" type="datetimeFigureOut">
              <a:rPr lang="en-US" smtClean="0"/>
              <a:t>9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B704B-E8A6-4BBA-87B8-246A026C1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625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CD867E-046E-44E4-99D4-23F228E76632}" type="datetimeFigureOut">
              <a:rPr lang="en-US" smtClean="0"/>
              <a:t>9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B704B-E8A6-4BBA-87B8-246A026C111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507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https://www-dep.iarc.fr/data/NORDCAN_G4_20200410a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7" t="10472" r="8370" b="22183"/>
          <a:stretch/>
        </p:blipFill>
        <p:spPr bwMode="auto">
          <a:xfrm>
            <a:off x="3798176" y="1549409"/>
            <a:ext cx="4595648" cy="51316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https://www-dep.iarc.fr/data/NORDCAN_G4_50444144a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02" t="10093" r="8190" b="22107"/>
          <a:stretch/>
        </p:blipFill>
        <p:spPr bwMode="auto">
          <a:xfrm>
            <a:off x="-1314" y="1549409"/>
            <a:ext cx="3799490" cy="51080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https://www-dep.iarc.fr/data/NORDCAN_G4_62100154a.pn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96" t="10868" r="2138" b="22702"/>
          <a:stretch/>
        </p:blipFill>
        <p:spPr bwMode="auto">
          <a:xfrm>
            <a:off x="8543596" y="1549409"/>
            <a:ext cx="3796861" cy="51001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542596" y="2109085"/>
            <a:ext cx="5281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A</a:t>
            </a:r>
            <a:endParaRPr lang="en-US" b="1" dirty="0"/>
          </a:p>
        </p:txBody>
      </p:sp>
      <p:sp>
        <p:nvSpPr>
          <p:cNvPr id="3" name="TextBox 2"/>
          <p:cNvSpPr txBox="1"/>
          <p:nvPr/>
        </p:nvSpPr>
        <p:spPr>
          <a:xfrm>
            <a:off x="4507623" y="2109085"/>
            <a:ext cx="3626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B</a:t>
            </a:r>
            <a:endParaRPr lang="en-US" b="1" dirty="0"/>
          </a:p>
        </p:txBody>
      </p:sp>
      <p:sp>
        <p:nvSpPr>
          <p:cNvPr id="4" name="TextBox 3"/>
          <p:cNvSpPr txBox="1"/>
          <p:nvPr/>
        </p:nvSpPr>
        <p:spPr>
          <a:xfrm>
            <a:off x="9071741" y="2109085"/>
            <a:ext cx="4815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C</a:t>
            </a:r>
            <a:endParaRPr lang="en-US" b="1" dirty="0"/>
          </a:p>
        </p:txBody>
      </p:sp>
      <p:sp>
        <p:nvSpPr>
          <p:cNvPr id="5" name="TextBox 4"/>
          <p:cNvSpPr txBox="1"/>
          <p:nvPr/>
        </p:nvSpPr>
        <p:spPr>
          <a:xfrm>
            <a:off x="706035" y="274248"/>
            <a:ext cx="1101746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Supplementary Fig. 1. </a:t>
            </a:r>
            <a:r>
              <a:rPr lang="en-US" dirty="0"/>
              <a:t>Comparison of age-standardized male incidence and mortality trends for Danish (A), Finnish (B) and Norwegian (C) patients. The top (red) graph is incidence, the bottom one (green) is mortality. The scales for x-and y-axis differ between the countries. The widths of the diagrams are shown in proportion to the lengths of the observation period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693622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https://www-dep.iarc.fr/data/NORDCAN_T_90100418a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6" t="12699" r="7719" b="12339"/>
          <a:stretch/>
        </p:blipFill>
        <p:spPr bwMode="auto">
          <a:xfrm>
            <a:off x="279990" y="1206650"/>
            <a:ext cx="5732059" cy="51547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https://www-dep.iarc.fr/data/NORDCAN_T_96702224a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8" t="13451" r="7654" b="12836"/>
          <a:stretch/>
        </p:blipFill>
        <p:spPr bwMode="auto">
          <a:xfrm>
            <a:off x="6134879" y="1204488"/>
            <a:ext cx="5736609" cy="50931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303572" y="1830329"/>
            <a:ext cx="559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7076576" y="1830329"/>
            <a:ext cx="423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632084" y="560319"/>
            <a:ext cx="105352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Supplementary Fig. 2. </a:t>
            </a:r>
            <a:r>
              <a:rPr lang="en-US" dirty="0"/>
              <a:t>Incidence trends for pleural mesothelioma in Finland (A) and Norway (B) by age groups.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33746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https://www-dep.iarc.fr/data/NORDCAN_C_202455881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7" t="6355" r="7915" b="5612"/>
          <a:stretch/>
        </p:blipFill>
        <p:spPr bwMode="auto">
          <a:xfrm>
            <a:off x="467902" y="946707"/>
            <a:ext cx="5628098" cy="58589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https://www-dep.iarc.fr/data/NORDCAN_C_120565031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09" t="6086" r="9589" b="6866"/>
          <a:stretch/>
        </p:blipFill>
        <p:spPr bwMode="auto">
          <a:xfrm>
            <a:off x="6207695" y="904387"/>
            <a:ext cx="5607853" cy="5815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289718" y="1285116"/>
            <a:ext cx="5343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069698" y="1285116"/>
            <a:ext cx="3836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012088" y="146415"/>
            <a:ext cx="1052834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Supplementary Fig. 3. </a:t>
            </a:r>
            <a:r>
              <a:rPr lang="en-US" dirty="0"/>
              <a:t>Pleural mesothelioma incidence trends for men from Sweden (A) and from the high-incidence western region (B) by birth cohorts. Note the logarithmic scale for the y-axis.</a:t>
            </a:r>
          </a:p>
        </p:txBody>
      </p:sp>
    </p:spTree>
    <p:extLst>
      <p:ext uri="{BB962C8B-B14F-4D97-AF65-F5344CB8AC3E}">
        <p14:creationId xmlns:p14="http://schemas.microsoft.com/office/powerpoint/2010/main" val="34547823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31" t="10509" r="7090" b="12167"/>
          <a:stretch/>
        </p:blipFill>
        <p:spPr>
          <a:xfrm>
            <a:off x="371605" y="963789"/>
            <a:ext cx="5532581" cy="5360275"/>
          </a:xfrm>
          <a:prstGeom prst="rect">
            <a:avLst/>
          </a:prstGeom>
        </p:spPr>
      </p:pic>
      <p:pic>
        <p:nvPicPr>
          <p:cNvPr id="1026" name="Picture 2" descr="https://www-dep.iarc.fr/data/NORDCAN_S_AGE4_34110546a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6" t="10069" r="6559" b="12552"/>
          <a:stretch/>
        </p:blipFill>
        <p:spPr bwMode="auto">
          <a:xfrm>
            <a:off x="5904186" y="963788"/>
            <a:ext cx="5659333" cy="53602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011504" y="1594131"/>
            <a:ext cx="4531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A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514088" y="1561763"/>
            <a:ext cx="4612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B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621570" y="409790"/>
            <a:ext cx="78154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Supplementary Fig. 4. </a:t>
            </a:r>
            <a:r>
              <a:rPr lang="en-US" dirty="0"/>
              <a:t>Relative 5-year survival for Nordic men (A) and women (B).</a:t>
            </a:r>
          </a:p>
        </p:txBody>
      </p:sp>
    </p:spTree>
    <p:extLst>
      <p:ext uri="{BB962C8B-B14F-4D97-AF65-F5344CB8AC3E}">
        <p14:creationId xmlns:p14="http://schemas.microsoft.com/office/powerpoint/2010/main" val="25333743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8</TotalTime>
  <Words>163</Words>
  <Application>Microsoft Office PowerPoint</Application>
  <PresentationFormat>Widescreen</PresentationFormat>
  <Paragraphs>13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DKF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mminki, Kari</dc:creator>
  <cp:lastModifiedBy>Hemminki Kari Jussi</cp:lastModifiedBy>
  <cp:revision>20</cp:revision>
  <dcterms:created xsi:type="dcterms:W3CDTF">2021-08-22T09:09:12Z</dcterms:created>
  <dcterms:modified xsi:type="dcterms:W3CDTF">2021-09-02T13:37:15Z</dcterms:modified>
</cp:coreProperties>
</file>